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rlene Wong" initials="CW" lastIdx="1" clrIdx="0">
    <p:extLst>
      <p:ext uri="{19B8F6BF-5375-455C-9EA6-DF929625EA0E}">
        <p15:presenceInfo xmlns:p15="http://schemas.microsoft.com/office/powerpoint/2012/main" userId="Charlene W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76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2394" y="-846"/>
      </p:cViewPr>
      <p:guideLst>
        <p:guide orient="horz" pos="386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398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396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491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544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649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8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366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076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266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384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226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5F302-DC16-4E92-97E9-A4EE71AE8970}" type="datetimeFigureOut">
              <a:rPr lang="en-US" smtClean="0"/>
              <a:t>2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F8000-C0F1-43D6-B0C1-276DABCF79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620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5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0" y="38100"/>
            <a:ext cx="16677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1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3529" y="296601"/>
            <a:ext cx="30469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RISMA 2009 Flow Diagram of Study Inclusion</a:t>
            </a:r>
          </a:p>
        </p:txBody>
      </p:sp>
      <p:grpSp>
        <p:nvGrpSpPr>
          <p:cNvPr id="31" name="Group 30"/>
          <p:cNvGrpSpPr/>
          <p:nvPr/>
        </p:nvGrpSpPr>
        <p:grpSpPr>
          <a:xfrm>
            <a:off x="239069" y="1035822"/>
            <a:ext cx="6429360" cy="10490517"/>
            <a:chOff x="-457200" y="914400"/>
            <a:chExt cx="7315200" cy="6756400"/>
          </a:xfrm>
        </p:grpSpPr>
        <p:sp>
          <p:nvSpPr>
            <p:cNvPr id="34" name="Rectangle 21"/>
            <p:cNvSpPr>
              <a:spLocks noChangeArrowheads="1"/>
            </p:cNvSpPr>
            <p:nvPr/>
          </p:nvSpPr>
          <p:spPr bwMode="auto">
            <a:xfrm>
              <a:off x="342900" y="1220788"/>
              <a:ext cx="2228850" cy="11874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Records identified through database searching 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901)</a:t>
              </a:r>
              <a:endParaRPr kumimoji="0" lang="en-CA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</a:t>
              </a:r>
              <a:r>
                <a:rPr kumimoji="0" lang="en-US" altLang="en-US" sz="11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Pubmed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/Medline, n = 839)</a:t>
              </a:r>
              <a:endPara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Cochrane, n =27)</a:t>
              </a:r>
              <a:endPara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</a:t>
              </a:r>
              <a:r>
                <a:rPr kumimoji="0" lang="en-US" altLang="en-US" sz="11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Embase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, n =35)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AutoShape 23"/>
            <p:cNvSpPr>
              <a:spLocks noChangeArrowheads="1"/>
            </p:cNvSpPr>
            <p:nvPr/>
          </p:nvSpPr>
          <p:spPr bwMode="auto">
            <a:xfrm rot="16200000">
              <a:off x="-994569" y="36361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cs typeface="Times New Roman" panose="02020603050405020304" pitchFamily="18" charset="0"/>
                </a:rPr>
                <a:t>Screening</a:t>
              </a:r>
              <a:endParaRPr kumimoji="0" lang="en-CA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AutoShape 1"/>
            <p:cNvSpPr>
              <a:spLocks noChangeArrowheads="1"/>
            </p:cNvSpPr>
            <p:nvPr/>
          </p:nvSpPr>
          <p:spPr bwMode="auto">
            <a:xfrm rot="16200000">
              <a:off x="-994569" y="68365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cs typeface="Times New Roman" panose="02020603050405020304" pitchFamily="18" charset="0"/>
                </a:rPr>
                <a:t>Included</a:t>
              </a:r>
              <a:endParaRPr kumimoji="0" lang="en-CA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AutoShape 22"/>
            <p:cNvSpPr>
              <a:spLocks noChangeArrowheads="1"/>
            </p:cNvSpPr>
            <p:nvPr/>
          </p:nvSpPr>
          <p:spPr bwMode="auto">
            <a:xfrm rot="16200000">
              <a:off x="-994569" y="52363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cs typeface="Times New Roman" panose="02020603050405020304" pitchFamily="18" charset="0"/>
                </a:rPr>
                <a:t>Eligibility</a:t>
              </a:r>
              <a:endParaRPr kumimoji="0" lang="en-CA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AutoShape 20"/>
            <p:cNvSpPr>
              <a:spLocks noChangeShapeType="1"/>
            </p:cNvSpPr>
            <p:nvPr/>
          </p:nvSpPr>
          <p:spPr bwMode="auto">
            <a:xfrm>
              <a:off x="1600200" y="2411413"/>
              <a:ext cx="0" cy="4572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AutoShape 19"/>
            <p:cNvSpPr>
              <a:spLocks noChangeShapeType="1"/>
            </p:cNvSpPr>
            <p:nvPr/>
          </p:nvSpPr>
          <p:spPr bwMode="auto">
            <a:xfrm>
              <a:off x="3886200" y="2411413"/>
              <a:ext cx="0" cy="4572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AutoShape 2"/>
            <p:cNvSpPr>
              <a:spLocks noChangeArrowheads="1"/>
            </p:cNvSpPr>
            <p:nvPr/>
          </p:nvSpPr>
          <p:spPr bwMode="auto">
            <a:xfrm rot="16200000">
              <a:off x="-994569" y="20359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cs typeface="Times New Roman" panose="02020603050405020304" pitchFamily="18" charset="0"/>
                </a:rPr>
                <a:t>Identification</a:t>
              </a:r>
              <a:endParaRPr kumimoji="0" lang="en-CA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18"/>
            <p:cNvSpPr>
              <a:spLocks noChangeArrowheads="1"/>
            </p:cNvSpPr>
            <p:nvPr/>
          </p:nvSpPr>
          <p:spPr bwMode="auto">
            <a:xfrm>
              <a:off x="2914650" y="1192213"/>
              <a:ext cx="2647950" cy="1219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Additional records identified through other sources</a:t>
              </a:r>
              <a:endParaRPr kumimoji="0" lang="en-CA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146)</a:t>
              </a:r>
              <a:br>
                <a:rPr kumimoji="0" lang="en-CA" altLang="en-US" sz="11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ClinicalTrials.gov, n = 68)</a:t>
              </a:r>
              <a:endParaRPr kumimoji="0" lang="en-CA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ASCO Meeting Library, n = 46)</a:t>
              </a:r>
              <a:endPara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Oxford Press ESMO Collection, n = 32) 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17"/>
            <p:cNvSpPr>
              <a:spLocks noChangeArrowheads="1"/>
            </p:cNvSpPr>
            <p:nvPr/>
          </p:nvSpPr>
          <p:spPr bwMode="auto">
            <a:xfrm>
              <a:off x="1357313" y="2868613"/>
              <a:ext cx="2771775" cy="5715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Records after duplicates removed 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994)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16"/>
            <p:cNvSpPr>
              <a:spLocks noChangeArrowheads="1"/>
            </p:cNvSpPr>
            <p:nvPr/>
          </p:nvSpPr>
          <p:spPr bwMode="auto">
            <a:xfrm>
              <a:off x="1908175" y="3770313"/>
              <a:ext cx="1670050" cy="7524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Title and Abstract Records screened 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48)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15"/>
            <p:cNvSpPr>
              <a:spLocks noChangeArrowheads="1"/>
            </p:cNvSpPr>
            <p:nvPr/>
          </p:nvSpPr>
          <p:spPr bwMode="auto">
            <a:xfrm>
              <a:off x="4198938" y="3740606"/>
              <a:ext cx="2286000" cy="86558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Records excluded </a:t>
              </a:r>
              <a:endParaRPr kumimoji="0" lang="en-CA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= 946)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N = 943 Excluded due to title or abstract content not meeting the hypothesis of the study</a:t>
              </a:r>
              <a:endParaRPr kumimoji="0" lang="en-CA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N=3 Abstract only, full article included in analysis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>
              <a:off x="1885950" y="4811713"/>
              <a:ext cx="1714500" cy="6858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CA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A</a:t>
              </a: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rticles assessed for eligibility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</a:t>
              </a:r>
              <a:r>
                <a:rPr lang="en-CA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48</a:t>
              </a: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)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13"/>
            <p:cNvSpPr>
              <a:spLocks noChangeArrowheads="1"/>
            </p:cNvSpPr>
            <p:nvPr/>
          </p:nvSpPr>
          <p:spPr bwMode="auto">
            <a:xfrm>
              <a:off x="4198938" y="4832350"/>
              <a:ext cx="2260600" cy="181322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CA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A</a:t>
              </a: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rticles excluded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41)</a:t>
              </a:r>
              <a:endParaRPr kumimoji="0" lang="en-CA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N=1 Trial terminated, no sufficient data for review</a:t>
              </a:r>
              <a:endPara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N=1 Trial excluded</a:t>
              </a:r>
              <a:r>
                <a:rPr lang="en-US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 due to </a:t>
              </a: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no appropriate comparator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N=1 Open-label/Non-Randomized Trial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N=2 Duplicate trials (not previously detected)</a:t>
              </a:r>
              <a:endPara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100" dirty="0">
                  <a:solidFill>
                    <a:srgbClr val="000000"/>
                  </a:solidFill>
                  <a:latin typeface="Calibri" panose="020F0502020204030204" pitchFamily="34" charset="0"/>
                </a:rPr>
                <a:t>N=9 Autologous T-Cell Therapy </a:t>
              </a:r>
              <a:endPara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N=27 Trials in Progress</a:t>
              </a:r>
              <a:endPara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7" name="Rectangle 12"/>
            <p:cNvSpPr>
              <a:spLocks noChangeArrowheads="1"/>
            </p:cNvSpPr>
            <p:nvPr/>
          </p:nvSpPr>
          <p:spPr bwMode="auto">
            <a:xfrm>
              <a:off x="1885950" y="5840413"/>
              <a:ext cx="1714500" cy="6858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Studies included in qualitative synthesis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</a:t>
              </a:r>
              <a:r>
                <a:rPr lang="en-CA" altLang="en-US" sz="1100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</a:rPr>
                <a:t>7</a:t>
              </a: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)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11"/>
            <p:cNvSpPr>
              <a:spLocks noChangeArrowheads="1"/>
            </p:cNvSpPr>
            <p:nvPr/>
          </p:nvSpPr>
          <p:spPr bwMode="auto">
            <a:xfrm>
              <a:off x="1896369" y="6872943"/>
              <a:ext cx="1714500" cy="56328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Studies included in quantitative synthesis (meta-analysis)</a:t>
              </a:r>
              <a:b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</a:br>
              <a:r>
                <a:rPr kumimoji="0" lang="en-CA" altLang="en-US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</a:rPr>
                <a:t>(n = 7)</a:t>
              </a:r>
              <a:endParaRPr kumimoji="0" lang="en-CA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AutoShape 10"/>
            <p:cNvSpPr>
              <a:spLocks noChangeShapeType="1"/>
            </p:cNvSpPr>
            <p:nvPr/>
          </p:nvSpPr>
          <p:spPr bwMode="auto">
            <a:xfrm>
              <a:off x="2743200" y="3440113"/>
              <a:ext cx="0" cy="3302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AutoShape 9"/>
            <p:cNvSpPr>
              <a:spLocks noChangeShapeType="1"/>
            </p:cNvSpPr>
            <p:nvPr/>
          </p:nvSpPr>
          <p:spPr bwMode="auto">
            <a:xfrm>
              <a:off x="2743200" y="4522788"/>
              <a:ext cx="0" cy="28892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AutoShape 8"/>
            <p:cNvSpPr>
              <a:spLocks noChangeShapeType="1"/>
            </p:cNvSpPr>
            <p:nvPr/>
          </p:nvSpPr>
          <p:spPr bwMode="auto">
            <a:xfrm>
              <a:off x="2743200" y="5497513"/>
              <a:ext cx="0" cy="3429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AutoShape 7"/>
            <p:cNvSpPr>
              <a:spLocks noChangeShapeType="1"/>
            </p:cNvSpPr>
            <p:nvPr/>
          </p:nvSpPr>
          <p:spPr bwMode="auto">
            <a:xfrm>
              <a:off x="2743200" y="6526213"/>
              <a:ext cx="0" cy="3429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AutoShape 6"/>
            <p:cNvSpPr>
              <a:spLocks noChangeShapeType="1"/>
            </p:cNvSpPr>
            <p:nvPr/>
          </p:nvSpPr>
          <p:spPr bwMode="auto">
            <a:xfrm>
              <a:off x="3578225" y="4146549"/>
              <a:ext cx="620713" cy="5125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AutoShape 5"/>
            <p:cNvSpPr>
              <a:spLocks noChangeShapeType="1"/>
            </p:cNvSpPr>
            <p:nvPr/>
          </p:nvSpPr>
          <p:spPr bwMode="auto">
            <a:xfrm>
              <a:off x="3600450" y="5154613"/>
              <a:ext cx="598488" cy="544512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Rectangle 41"/>
            <p:cNvSpPr>
              <a:spLocks noChangeArrowheads="1"/>
            </p:cNvSpPr>
            <p:nvPr/>
          </p:nvSpPr>
          <p:spPr bwMode="auto">
            <a:xfrm>
              <a:off x="0" y="914400"/>
              <a:ext cx="6858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638270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2</TotalTime>
  <Words>237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elali</dc:creator>
  <cp:lastModifiedBy>ahelali</cp:lastModifiedBy>
  <cp:revision>20</cp:revision>
  <dcterms:created xsi:type="dcterms:W3CDTF">2021-01-08T11:35:20Z</dcterms:created>
  <dcterms:modified xsi:type="dcterms:W3CDTF">2022-02-25T06:09:22Z</dcterms:modified>
</cp:coreProperties>
</file>